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28759-0991-4FE2-B2A8-061862A667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37D09-95D7-45E7-88B2-3D510F2330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B9964-BA7E-4F0D-8D0A-7F2B81903B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C5590-29D6-47F2-A47D-5C325FDFAD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110CD-2D2C-44A0-8D9D-9FF8129AD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CB32D-A3CD-4852-99D9-8C39793B02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11B1A-4A49-4D85-8D76-5B08B55649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03137-05EE-46F5-A10A-902C5AAB3D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08D55-357E-4DE7-A4B0-39E801D67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0FE33-DD5D-4669-8D0D-B84D6BCAE4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F98A7-D645-41A4-A03A-9A3B2C5DEF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8EE14-A0B2-44A1-AAFE-F557B8BAC4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E632EA-ADE9-4E16-8C6C-2580FA4E58A9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60" y="380880"/>
            <a:ext cx="6705360" cy="8534160"/>
            <a:chOff x="360" y="380880"/>
            <a:chExt cx="6705360" cy="8534160"/>
          </a:xfrm>
        </p:grpSpPr>
        <p:grpSp>
          <p:nvGrpSpPr>
            <p:cNvPr id="42" name=""/>
            <p:cNvGrpSpPr/>
            <p:nvPr/>
          </p:nvGrpSpPr>
          <p:grpSpPr>
            <a:xfrm>
              <a:off x="360" y="380880"/>
              <a:ext cx="3123360" cy="2590920"/>
              <a:chOff x="360" y="380880"/>
              <a:chExt cx="3123360" cy="2590920"/>
            </a:xfrm>
          </p:grpSpPr>
          <p:sp>
            <p:nvSpPr>
              <p:cNvPr id="43" name=""/>
              <p:cNvSpPr/>
              <p:nvPr/>
            </p:nvSpPr>
            <p:spPr>
              <a:xfrm>
                <a:off x="360" y="380880"/>
                <a:ext cx="988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2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63720" y="819360"/>
                <a:ext cx="3060000" cy="2152440"/>
                <a:chOff x="63720" y="819360"/>
                <a:chExt cx="3060000" cy="2152440"/>
              </a:xfrm>
            </p:grpSpPr>
            <p:pic>
              <p:nvPicPr>
                <p:cNvPr id="45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63720" y="819360"/>
                  <a:ext cx="3060000" cy="2152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6" name=""/>
                <p:cNvSpPr/>
                <p:nvPr/>
              </p:nvSpPr>
              <p:spPr>
                <a:xfrm>
                  <a:off x="2071440" y="1595160"/>
                  <a:ext cx="541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D (Asp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1833480" y="1997280"/>
                  <a:ext cx="515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E (Glu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8" name=""/>
            <p:cNvGrpSpPr/>
            <p:nvPr/>
          </p:nvGrpSpPr>
          <p:grpSpPr>
            <a:xfrm>
              <a:off x="3343320" y="387360"/>
              <a:ext cx="3166920" cy="2606400"/>
              <a:chOff x="3343320" y="387360"/>
              <a:chExt cx="3166920" cy="2606400"/>
            </a:xfrm>
          </p:grpSpPr>
          <p:pic>
            <p:nvPicPr>
              <p:cNvPr id="49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505320" y="914400"/>
                <a:ext cx="3004920" cy="2079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"/>
              <p:cNvSpPr/>
              <p:nvPr/>
            </p:nvSpPr>
            <p:spPr>
              <a:xfrm>
                <a:off x="3343320" y="387360"/>
                <a:ext cx="988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8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5197680" y="1879560"/>
                <a:ext cx="42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I (Ile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167800" y="163836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V (Va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77400" y="3352680"/>
              <a:ext cx="3080160" cy="2514600"/>
              <a:chOff x="77400" y="3352680"/>
              <a:chExt cx="3080160" cy="2514600"/>
            </a:xfrm>
          </p:grpSpPr>
          <p:pic>
            <p:nvPicPr>
              <p:cNvPr id="54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152280" y="3786120"/>
                <a:ext cx="3005280" cy="2081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"/>
              <p:cNvSpPr/>
              <p:nvPr/>
            </p:nvSpPr>
            <p:spPr>
              <a:xfrm>
                <a:off x="77400" y="335268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13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056960" y="4732200"/>
                <a:ext cx="508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H (His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795320" y="463068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Y (Try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"/>
            <p:cNvGrpSpPr/>
            <p:nvPr/>
          </p:nvGrpSpPr>
          <p:grpSpPr>
            <a:xfrm>
              <a:off x="3498480" y="3429000"/>
              <a:ext cx="3207240" cy="2466720"/>
              <a:chOff x="3498480" y="3429000"/>
              <a:chExt cx="3207240" cy="2466720"/>
            </a:xfrm>
          </p:grpSpPr>
          <p:pic>
            <p:nvPicPr>
              <p:cNvPr id="59" name="" descr=""/>
              <p:cNvPicPr/>
              <p:nvPr/>
            </p:nvPicPr>
            <p:blipFill>
              <a:blip r:embed="rId4"/>
              <a:srcRect l="0" t="0" r="784" b="0"/>
              <a:stretch/>
            </p:blipFill>
            <p:spPr>
              <a:xfrm>
                <a:off x="3606840" y="3733560"/>
                <a:ext cx="3098880" cy="2162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"/>
              <p:cNvSpPr/>
              <p:nvPr/>
            </p:nvSpPr>
            <p:spPr>
              <a:xfrm>
                <a:off x="3498480" y="342900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1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383800" y="4524120"/>
                <a:ext cx="515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E (Glu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721760" y="4379760"/>
                <a:ext cx="541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D (As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3" name=""/>
            <p:cNvGrpSpPr/>
            <p:nvPr/>
          </p:nvGrpSpPr>
          <p:grpSpPr>
            <a:xfrm>
              <a:off x="76320" y="6431040"/>
              <a:ext cx="3114720" cy="2484000"/>
              <a:chOff x="76320" y="6431040"/>
              <a:chExt cx="3114720" cy="2484000"/>
            </a:xfrm>
          </p:grpSpPr>
          <p:pic>
            <p:nvPicPr>
              <p:cNvPr id="64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76320" y="6759360"/>
                <a:ext cx="3114720" cy="2155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>
                <a:off x="304560" y="643104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1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992160" y="7786440"/>
                <a:ext cx="508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 (Ala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502280" y="805644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V (Va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8" name=""/>
          <p:cNvSpPr/>
          <p:nvPr/>
        </p:nvSpPr>
        <p:spPr>
          <a:xfrm>
            <a:off x="2086560" y="0"/>
            <a:ext cx="187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"/>
          <p:cNvGrpSpPr/>
          <p:nvPr/>
        </p:nvGrpSpPr>
        <p:grpSpPr>
          <a:xfrm>
            <a:off x="76320" y="174600"/>
            <a:ext cx="6684840" cy="9321840"/>
            <a:chOff x="76320" y="174600"/>
            <a:chExt cx="6684840" cy="9321840"/>
          </a:xfrm>
        </p:grpSpPr>
        <p:grpSp>
          <p:nvGrpSpPr>
            <p:cNvPr id="70" name=""/>
            <p:cNvGrpSpPr/>
            <p:nvPr/>
          </p:nvGrpSpPr>
          <p:grpSpPr>
            <a:xfrm>
              <a:off x="228600" y="174600"/>
              <a:ext cx="3124080" cy="2444760"/>
              <a:chOff x="228600" y="174600"/>
              <a:chExt cx="3124080" cy="2444760"/>
            </a:xfrm>
          </p:grpSpPr>
          <p:sp>
            <p:nvSpPr>
              <p:cNvPr id="71" name=""/>
              <p:cNvSpPr/>
              <p:nvPr/>
            </p:nvSpPr>
            <p:spPr>
              <a:xfrm>
                <a:off x="304920" y="174600"/>
                <a:ext cx="1183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270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2" name=""/>
              <p:cNvGrpSpPr/>
              <p:nvPr/>
            </p:nvGrpSpPr>
            <p:grpSpPr>
              <a:xfrm>
                <a:off x="228600" y="457200"/>
                <a:ext cx="3124080" cy="2162160"/>
                <a:chOff x="228600" y="457200"/>
                <a:chExt cx="3124080" cy="2162160"/>
              </a:xfrm>
            </p:grpSpPr>
            <p:pic>
              <p:nvPicPr>
                <p:cNvPr id="73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28600" y="457200"/>
                  <a:ext cx="3124080" cy="2162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4" name=""/>
                <p:cNvSpPr/>
                <p:nvPr/>
              </p:nvSpPr>
              <p:spPr>
                <a:xfrm>
                  <a:off x="1168200" y="1592280"/>
                  <a:ext cx="503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T (Thr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1742040" y="1476360"/>
                  <a:ext cx="541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N (Asp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6" name=""/>
            <p:cNvGrpSpPr/>
            <p:nvPr/>
          </p:nvGrpSpPr>
          <p:grpSpPr>
            <a:xfrm>
              <a:off x="3700440" y="206280"/>
              <a:ext cx="3004920" cy="2384640"/>
              <a:chOff x="3700440" y="206280"/>
              <a:chExt cx="3004920" cy="2384640"/>
            </a:xfrm>
          </p:grpSpPr>
          <p:pic>
            <p:nvPicPr>
              <p:cNvPr id="77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700440" y="511200"/>
                <a:ext cx="3004920" cy="2079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"/>
              <p:cNvSpPr/>
              <p:nvPr/>
            </p:nvSpPr>
            <p:spPr>
              <a:xfrm>
                <a:off x="4867200" y="1519200"/>
                <a:ext cx="42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I (Ile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005000" y="206280"/>
                <a:ext cx="111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270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379480" y="142560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T (Th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"/>
            <p:cNvGrpSpPr/>
            <p:nvPr/>
          </p:nvGrpSpPr>
          <p:grpSpPr>
            <a:xfrm>
              <a:off x="380880" y="3359160"/>
              <a:ext cx="2853000" cy="1974600"/>
              <a:chOff x="380880" y="3359160"/>
              <a:chExt cx="2853000" cy="1974600"/>
            </a:xfrm>
          </p:grpSpPr>
          <p:grpSp>
            <p:nvGrpSpPr>
              <p:cNvPr id="82" name=""/>
              <p:cNvGrpSpPr/>
              <p:nvPr/>
            </p:nvGrpSpPr>
            <p:grpSpPr>
              <a:xfrm>
                <a:off x="380880" y="3359160"/>
                <a:ext cx="2853000" cy="1974600"/>
                <a:chOff x="380880" y="3359160"/>
                <a:chExt cx="2853000" cy="1974600"/>
              </a:xfrm>
            </p:grpSpPr>
            <p:pic>
              <p:nvPicPr>
                <p:cNvPr id="83" name="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380880" y="3359160"/>
                  <a:ext cx="2853000" cy="1974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4" name=""/>
                <p:cNvSpPr/>
                <p:nvPr/>
              </p:nvSpPr>
              <p:spPr>
                <a:xfrm>
                  <a:off x="609480" y="3429000"/>
                  <a:ext cx="1166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BR" sz="1200" spc="-1" strike="noStrike">
                      <a:solidFill>
                        <a:srgbClr val="000000"/>
                      </a:solidFill>
                      <a:latin typeface="Arial"/>
                    </a:rPr>
                    <a:t>Residue 301T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5" name=""/>
              <p:cNvSpPr/>
              <p:nvPr/>
            </p:nvSpPr>
            <p:spPr>
              <a:xfrm>
                <a:off x="1850760" y="388620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T (Th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162800" y="3867120"/>
                <a:ext cx="52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L (Leu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"/>
            <p:cNvGrpSpPr/>
            <p:nvPr/>
          </p:nvGrpSpPr>
          <p:grpSpPr>
            <a:xfrm>
              <a:off x="3332160" y="3290760"/>
              <a:ext cx="3429000" cy="2011320"/>
              <a:chOff x="3332160" y="3290760"/>
              <a:chExt cx="3429000" cy="2011320"/>
            </a:xfrm>
          </p:grpSpPr>
          <p:pic>
            <p:nvPicPr>
              <p:cNvPr id="88" name="" descr=""/>
              <p:cNvPicPr/>
              <p:nvPr/>
            </p:nvPicPr>
            <p:blipFill>
              <a:blip r:embed="rId4"/>
              <a:srcRect l="0" t="21133" r="0" b="0"/>
              <a:stretch/>
            </p:blipFill>
            <p:spPr>
              <a:xfrm>
                <a:off x="3332160" y="3429000"/>
                <a:ext cx="3429000" cy="1873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"/>
              <p:cNvSpPr/>
              <p:nvPr/>
            </p:nvSpPr>
            <p:spPr>
              <a:xfrm>
                <a:off x="4250880" y="3290760"/>
                <a:ext cx="1175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301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153760" y="4130640"/>
                <a:ext cx="520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L (Leu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736160" y="3733920"/>
                <a:ext cx="509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 (Se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"/>
            <p:cNvGrpSpPr/>
            <p:nvPr/>
          </p:nvGrpSpPr>
          <p:grpSpPr>
            <a:xfrm>
              <a:off x="76320" y="5905440"/>
              <a:ext cx="2514600" cy="2781360"/>
              <a:chOff x="76320" y="5905440"/>
              <a:chExt cx="2514600" cy="2781360"/>
            </a:xfrm>
          </p:grpSpPr>
          <p:pic>
            <p:nvPicPr>
              <p:cNvPr id="93" name="" descr=""/>
              <p:cNvPicPr/>
              <p:nvPr/>
            </p:nvPicPr>
            <p:blipFill>
              <a:blip r:embed="rId5"/>
              <a:srcRect l="29676" t="0" r="0" b="0"/>
              <a:stretch/>
            </p:blipFill>
            <p:spPr>
              <a:xfrm>
                <a:off x="76320" y="6210360"/>
                <a:ext cx="2514600" cy="247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"/>
              <p:cNvSpPr/>
              <p:nvPr/>
            </p:nvSpPr>
            <p:spPr>
              <a:xfrm>
                <a:off x="204480" y="590544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30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748440" y="6996240"/>
                <a:ext cx="541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N (As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09800" y="708516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G(Gly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3098880" y="5715000"/>
              <a:ext cx="3650760" cy="3781440"/>
              <a:chOff x="3098880" y="5715000"/>
              <a:chExt cx="3650760" cy="3781440"/>
            </a:xfrm>
          </p:grpSpPr>
          <p:pic>
            <p:nvPicPr>
              <p:cNvPr id="98" name="" descr=""/>
              <p:cNvPicPr/>
              <p:nvPr/>
            </p:nvPicPr>
            <p:blipFill>
              <a:blip r:embed="rId6"/>
              <a:srcRect l="11905" t="6020" r="20424" b="4567"/>
              <a:stretch/>
            </p:blipFill>
            <p:spPr>
              <a:xfrm>
                <a:off x="3098880" y="6197760"/>
                <a:ext cx="3606840" cy="329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9" name=""/>
              <p:cNvSpPr/>
              <p:nvPr/>
            </p:nvSpPr>
            <p:spPr>
              <a:xfrm>
                <a:off x="4265280" y="5715000"/>
                <a:ext cx="1671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380,383,38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995000" y="7467480"/>
                <a:ext cx="541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N (As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5514840" y="737064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K (Lys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5487840" y="656892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T (Th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5953320" y="6873840"/>
                <a:ext cx="42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I (Ile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5454720" y="6988320"/>
                <a:ext cx="533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173640" y="788364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K (Lys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6253560" y="739152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R(Arg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6095880" y="7848720"/>
                <a:ext cx="15264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"/>
          <p:cNvGrpSpPr/>
          <p:nvPr/>
        </p:nvGrpSpPr>
        <p:grpSpPr>
          <a:xfrm>
            <a:off x="0" y="3240"/>
            <a:ext cx="6781680" cy="9673560"/>
            <a:chOff x="0" y="3240"/>
            <a:chExt cx="6781680" cy="9673560"/>
          </a:xfrm>
        </p:grpSpPr>
        <p:grpSp>
          <p:nvGrpSpPr>
            <p:cNvPr id="109" name=""/>
            <p:cNvGrpSpPr/>
            <p:nvPr/>
          </p:nvGrpSpPr>
          <p:grpSpPr>
            <a:xfrm>
              <a:off x="228600" y="790560"/>
              <a:ext cx="2928960" cy="2657160"/>
              <a:chOff x="228600" y="790560"/>
              <a:chExt cx="2928960" cy="2657160"/>
            </a:xfrm>
          </p:grpSpPr>
          <p:pic>
            <p:nvPicPr>
              <p:cNvPr id="110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228600" y="1252800"/>
                <a:ext cx="2928960" cy="219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1" name=""/>
              <p:cNvSpPr/>
              <p:nvPr/>
            </p:nvSpPr>
            <p:spPr>
              <a:xfrm>
                <a:off x="365040" y="790560"/>
                <a:ext cx="988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784520" y="2143440"/>
                <a:ext cx="42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I (Ile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108440" y="216036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V (Va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"/>
            <p:cNvGrpSpPr/>
            <p:nvPr/>
          </p:nvGrpSpPr>
          <p:grpSpPr>
            <a:xfrm>
              <a:off x="3429000" y="757080"/>
              <a:ext cx="3233880" cy="2673000"/>
              <a:chOff x="3429000" y="757080"/>
              <a:chExt cx="3233880" cy="2673000"/>
            </a:xfrm>
          </p:grpSpPr>
          <p:pic>
            <p:nvPicPr>
              <p:cNvPr id="115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429000" y="1004760"/>
                <a:ext cx="3233880" cy="2425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6" name=""/>
              <p:cNvSpPr/>
              <p:nvPr/>
            </p:nvSpPr>
            <p:spPr>
              <a:xfrm>
                <a:off x="3657240" y="75708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16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981240" y="1787400"/>
                <a:ext cx="508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 (Ala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729680" y="208836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V (Va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H="1" flipV="1">
                <a:off x="4419720" y="1913040"/>
                <a:ext cx="304560" cy="8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800600" y="1930320"/>
                <a:ext cx="76320" cy="16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"/>
            <p:cNvGrpSpPr/>
            <p:nvPr/>
          </p:nvGrpSpPr>
          <p:grpSpPr>
            <a:xfrm>
              <a:off x="151920" y="3811680"/>
              <a:ext cx="3081960" cy="2310840"/>
              <a:chOff x="151920" y="3811680"/>
              <a:chExt cx="3081960" cy="2310840"/>
            </a:xfrm>
          </p:grpSpPr>
          <p:pic>
            <p:nvPicPr>
              <p:cNvPr id="122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152280" y="3811680"/>
                <a:ext cx="3081600" cy="2310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3" name=""/>
              <p:cNvSpPr/>
              <p:nvPr/>
            </p:nvSpPr>
            <p:spPr>
              <a:xfrm>
                <a:off x="1758960" y="432216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R (Arg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1911240" y="452160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K (Lys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151920" y="389412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23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" name=""/>
            <p:cNvGrpSpPr/>
            <p:nvPr/>
          </p:nvGrpSpPr>
          <p:grpSpPr>
            <a:xfrm>
              <a:off x="3243240" y="3846600"/>
              <a:ext cx="3538440" cy="2606400"/>
              <a:chOff x="3243240" y="3846600"/>
              <a:chExt cx="3538440" cy="2606400"/>
            </a:xfrm>
          </p:grpSpPr>
          <p:pic>
            <p:nvPicPr>
              <p:cNvPr id="127" name="" descr=""/>
              <p:cNvPicPr/>
              <p:nvPr/>
            </p:nvPicPr>
            <p:blipFill>
              <a:blip r:embed="rId4"/>
              <a:srcRect l="8390" t="11406" r="0" b="0"/>
              <a:stretch/>
            </p:blipFill>
            <p:spPr>
              <a:xfrm>
                <a:off x="3243240" y="3887640"/>
                <a:ext cx="3538440" cy="2565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8" name=""/>
              <p:cNvSpPr/>
              <p:nvPr/>
            </p:nvSpPr>
            <p:spPr>
              <a:xfrm>
                <a:off x="3657240" y="384660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30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116240" y="538056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T (Th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5141880" y="5110200"/>
                <a:ext cx="508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 (Ala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H="1">
                <a:off x="4571640" y="5380560"/>
                <a:ext cx="152280" cy="8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952880" y="521496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"/>
            <p:cNvGrpSpPr/>
            <p:nvPr/>
          </p:nvGrpSpPr>
          <p:grpSpPr>
            <a:xfrm>
              <a:off x="0" y="6783480"/>
              <a:ext cx="3309840" cy="2893320"/>
              <a:chOff x="0" y="6783480"/>
              <a:chExt cx="3309840" cy="2893320"/>
            </a:xfrm>
          </p:grpSpPr>
          <p:pic>
            <p:nvPicPr>
              <p:cNvPr id="134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0" y="7195680"/>
                <a:ext cx="3309840" cy="2481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5" name=""/>
              <p:cNvSpPr/>
              <p:nvPr/>
            </p:nvSpPr>
            <p:spPr>
              <a:xfrm>
                <a:off x="456840" y="678348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39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166840" y="824328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R (Arg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677960" y="892908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K (Lys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1981080" y="8373600"/>
                <a:ext cx="228600" cy="8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1676520" y="8764200"/>
                <a:ext cx="109440" cy="19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0" name=""/>
            <p:cNvSpPr/>
            <p:nvPr/>
          </p:nvSpPr>
          <p:spPr>
            <a:xfrm>
              <a:off x="2323440" y="3240"/>
              <a:ext cx="186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Supplementary Figure 1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"/>
          <p:cNvGrpSpPr/>
          <p:nvPr/>
        </p:nvGrpSpPr>
        <p:grpSpPr>
          <a:xfrm>
            <a:off x="364680" y="3240"/>
            <a:ext cx="3859560" cy="4181400"/>
            <a:chOff x="364680" y="3240"/>
            <a:chExt cx="3859560" cy="4181400"/>
          </a:xfrm>
        </p:grpSpPr>
        <p:grpSp>
          <p:nvGrpSpPr>
            <p:cNvPr id="142" name=""/>
            <p:cNvGrpSpPr/>
            <p:nvPr/>
          </p:nvGrpSpPr>
          <p:grpSpPr>
            <a:xfrm>
              <a:off x="364680" y="723960"/>
              <a:ext cx="3859560" cy="3460680"/>
              <a:chOff x="364680" y="723960"/>
              <a:chExt cx="3859560" cy="3460680"/>
            </a:xfrm>
          </p:grpSpPr>
          <p:pic>
            <p:nvPicPr>
              <p:cNvPr id="1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380880" y="1523880"/>
                <a:ext cx="3843360" cy="2660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4" name=""/>
              <p:cNvSpPr/>
              <p:nvPr/>
            </p:nvSpPr>
            <p:spPr>
              <a:xfrm>
                <a:off x="364680" y="723960"/>
                <a:ext cx="107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200" spc="-1" strike="noStrike">
                    <a:solidFill>
                      <a:srgbClr val="000000"/>
                    </a:solidFill>
                    <a:latin typeface="Arial"/>
                  </a:rPr>
                  <a:t>Residue 1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229120" y="2654280"/>
                <a:ext cx="42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I (Ile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353960" y="2260440"/>
                <a:ext cx="503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800" spc="-1" strike="noStrike">
                    <a:solidFill>
                      <a:srgbClr val="000000"/>
                    </a:solidFill>
                    <a:latin typeface="Arial"/>
                  </a:rPr>
                  <a:t>T (Th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H="1">
                <a:off x="1828440" y="236232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050920" y="2654280"/>
                <a:ext cx="22860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"/>
            <p:cNvSpPr/>
            <p:nvPr/>
          </p:nvSpPr>
          <p:spPr>
            <a:xfrm>
              <a:off x="383040" y="3240"/>
              <a:ext cx="187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Supplementary Figure 1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2T11:59:39Z</dcterms:created>
  <dc:creator>Demo Unit</dc:creator>
  <dc:description/>
  <dc:language>en-US</dc:language>
  <cp:lastModifiedBy>Demo Unit</cp:lastModifiedBy>
  <dcterms:modified xsi:type="dcterms:W3CDTF">2009-04-25T14:36:30Z</dcterms:modified>
  <cp:revision>14</cp:revision>
  <dc:subject/>
  <dc:title>PowerPoint Presentation</dc:title>
</cp:coreProperties>
</file>